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6" autoAdjust="0"/>
    <p:restoredTop sz="94660"/>
  </p:normalViewPr>
  <p:slideViewPr>
    <p:cSldViewPr snapToGrid="0">
      <p:cViewPr varScale="1">
        <p:scale>
          <a:sx n="68" d="100"/>
          <a:sy n="68" d="100"/>
        </p:scale>
        <p:origin x="232" y="9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4310FE-4428-43FA-A7F1-BBF1EA249BCD}" type="datetimeFigureOut">
              <a:rPr lang="en-US" smtClean="0"/>
              <a:t>5/25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3B4118-C979-4ED6-B790-AA2B74549F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8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Table: Unadjusted post-discharge outcomes stratified by VTE incidence and resection type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D0DDD3-23E0-411E-A91F-3BCA88D02D2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24791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67128-9AAB-41C7-9B7E-9C6E0FCB68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D9E6ACF-34F7-4801-8B4E-C5BF44DDF9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C23E0C-C9A2-471A-9E7A-BA0F69CBC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D443ED-DCA6-49DA-A727-F8B7D9367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C2C92C-5EE5-4E20-8CC5-D9791CB4F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463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E58C1B-C315-4B11-B226-8EB477464B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7A67CD-CD98-4671-A396-4E322BC18F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00498C-3320-429B-8F2F-EB2AA8D731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C2C9C-A2DB-4B47-95DD-D3875D469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7B6322-A6EB-4BB9-8F11-84792956FD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200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4212A6-AB03-4852-ADCB-8F2E815F6A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52242D-71CD-48B2-80F3-96F341E0F4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42082F-F7B4-411F-8888-56FBAC2EF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B57E7E-9B71-43BB-83B7-E6EFD349F4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00743A-A39C-4C9D-BB04-80633F59A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100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DF7780-22DD-4B11-AFB6-848F8F36EF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92DF9B-E62E-4963-AB35-9F48822C38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60118F-FFC6-4974-9C70-8E458FB85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60D079-2E8B-458E-83C2-4F6CAED34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EF3BD7-F91D-449A-8EBA-D7CBB3A92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642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1A9C11-6734-40CA-85D1-B65CDF1CA5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3C2824-460F-46B0-B2BC-47F2615FC6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552A5D-51E2-4E65-9D97-512902C56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69E906-0FE2-4B8B-95F4-AC754AB57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16B363-1BE5-4F15-BD0F-77084096D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219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F0C792-640A-4564-90D3-725C6094F4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20566C-6CE7-422F-8DA8-86F9B7AD11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E678A3-86CC-4AC9-97D8-87C09CE45B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531E3B-C7E0-485E-9775-BB304E1DA6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C7B7CB-2B05-4843-8D13-B2F21FF9B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7F3ABE-74A5-4DD5-9597-AA7B77CB5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332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340B59-5465-4E42-BCA1-4EDDA87B95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2D826A-724D-4C09-9E21-BD7B566148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ABEA3F-79A2-425A-B14B-8F5917D7D3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BCE76E9-0CA9-463B-AA98-B32E13C7ED7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1CEB530-C292-4116-9BF2-C0DDAE5D1D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25031E-454B-47A2-BDF1-5DF1F05D92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D3D0F1E-AE00-49D5-A181-33E61A98B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1A741D-AAC4-4745-8810-C8026712B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942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AAB7DE-B123-4522-8564-9998E0FF73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F9E7148-37FB-4B54-9E75-DB6DBE142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4F2204-48E8-4F4F-AAB7-C841B3E97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1942DAF-D2AA-436E-A2B6-0B50696325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627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C479DA-5DE2-47C5-954D-36655DA710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403AD5-076B-45DE-A77C-F00BCB89C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38B1D6-7D74-47DC-B27D-12D9BCBBA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2593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CEF5C0-470D-4B3F-B9C5-3C8A7DE915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5084F8-F638-451A-A7D1-3B65C8F3A7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F8F6C0-6C42-4DE7-B2E0-23F7441AF2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884D53-7D18-4670-AB02-26ABF5D1AE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2B9A13-5775-41AA-BE06-9290BBF7AB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15CC88-DAE9-4040-BA3A-FF4E3E63A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588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30730B-9428-4373-9B8F-46E8FA1E58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2883B43-9ABC-4C18-87A0-8B52582900B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A80C5D-4D91-4E50-BEB5-F3D23D9C24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FE64E6-FC7D-4A18-8E68-D9832C5400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29C8D5-4118-499B-99C5-5BD9A2C78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254D49-5424-44C2-BF1D-45D6B0AD6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154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07F1DAB-EEBD-44D7-A1E3-165988383A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7C9D83-3A50-46B9-9E48-7205506574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343BD4-5599-4225-BC5E-4365D9B503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3E50FF-1CC5-48E2-BECC-18DE8A6EB2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300A19-9098-472E-9865-9F3CD3696F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086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57C9712-5BE3-4735-A1A0-4F215EA2CF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0807761"/>
              </p:ext>
            </p:extLst>
          </p:nvPr>
        </p:nvGraphicFramePr>
        <p:xfrm>
          <a:off x="67339" y="75777"/>
          <a:ext cx="12085675" cy="446036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00224">
                  <a:extLst>
                    <a:ext uri="{9D8B030D-6E8A-4147-A177-3AD203B41FA5}">
                      <a16:colId xmlns:a16="http://schemas.microsoft.com/office/drawing/2014/main" val="17100943"/>
                    </a:ext>
                  </a:extLst>
                </a:gridCol>
                <a:gridCol w="890476">
                  <a:extLst>
                    <a:ext uri="{9D8B030D-6E8A-4147-A177-3AD203B41FA5}">
                      <a16:colId xmlns:a16="http://schemas.microsoft.com/office/drawing/2014/main" val="1926407726"/>
                    </a:ext>
                  </a:extLst>
                </a:gridCol>
                <a:gridCol w="693775">
                  <a:extLst>
                    <a:ext uri="{9D8B030D-6E8A-4147-A177-3AD203B41FA5}">
                      <a16:colId xmlns:a16="http://schemas.microsoft.com/office/drawing/2014/main" val="2939187775"/>
                    </a:ext>
                  </a:extLst>
                </a:gridCol>
                <a:gridCol w="614325">
                  <a:extLst>
                    <a:ext uri="{9D8B030D-6E8A-4147-A177-3AD203B41FA5}">
                      <a16:colId xmlns:a16="http://schemas.microsoft.com/office/drawing/2014/main" val="987356811"/>
                    </a:ext>
                  </a:extLst>
                </a:gridCol>
                <a:gridCol w="1009439">
                  <a:extLst>
                    <a:ext uri="{9D8B030D-6E8A-4147-A177-3AD203B41FA5}">
                      <a16:colId xmlns:a16="http://schemas.microsoft.com/office/drawing/2014/main" val="796674737"/>
                    </a:ext>
                  </a:extLst>
                </a:gridCol>
                <a:gridCol w="672869">
                  <a:extLst>
                    <a:ext uri="{9D8B030D-6E8A-4147-A177-3AD203B41FA5}">
                      <a16:colId xmlns:a16="http://schemas.microsoft.com/office/drawing/2014/main" val="221150834"/>
                    </a:ext>
                  </a:extLst>
                </a:gridCol>
                <a:gridCol w="603692">
                  <a:extLst>
                    <a:ext uri="{9D8B030D-6E8A-4147-A177-3AD203B41FA5}">
                      <a16:colId xmlns:a16="http://schemas.microsoft.com/office/drawing/2014/main" val="305090455"/>
                    </a:ext>
                  </a:extLst>
                </a:gridCol>
                <a:gridCol w="938213">
                  <a:extLst>
                    <a:ext uri="{9D8B030D-6E8A-4147-A177-3AD203B41FA5}">
                      <a16:colId xmlns:a16="http://schemas.microsoft.com/office/drawing/2014/main" val="3925267882"/>
                    </a:ext>
                  </a:extLst>
                </a:gridCol>
                <a:gridCol w="741253">
                  <a:extLst>
                    <a:ext uri="{9D8B030D-6E8A-4147-A177-3AD203B41FA5}">
                      <a16:colId xmlns:a16="http://schemas.microsoft.com/office/drawing/2014/main" val="3897817598"/>
                    </a:ext>
                  </a:extLst>
                </a:gridCol>
                <a:gridCol w="577000">
                  <a:extLst>
                    <a:ext uri="{9D8B030D-6E8A-4147-A177-3AD203B41FA5}">
                      <a16:colId xmlns:a16="http://schemas.microsoft.com/office/drawing/2014/main" val="2414900560"/>
                    </a:ext>
                  </a:extLst>
                </a:gridCol>
                <a:gridCol w="777247">
                  <a:extLst>
                    <a:ext uri="{9D8B030D-6E8A-4147-A177-3AD203B41FA5}">
                      <a16:colId xmlns:a16="http://schemas.microsoft.com/office/drawing/2014/main" val="2305288647"/>
                    </a:ext>
                  </a:extLst>
                </a:gridCol>
                <a:gridCol w="774700">
                  <a:extLst>
                    <a:ext uri="{9D8B030D-6E8A-4147-A177-3AD203B41FA5}">
                      <a16:colId xmlns:a16="http://schemas.microsoft.com/office/drawing/2014/main" val="2060724066"/>
                    </a:ext>
                  </a:extLst>
                </a:gridCol>
                <a:gridCol w="595829">
                  <a:extLst>
                    <a:ext uri="{9D8B030D-6E8A-4147-A177-3AD203B41FA5}">
                      <a16:colId xmlns:a16="http://schemas.microsoft.com/office/drawing/2014/main" val="2190973037"/>
                    </a:ext>
                  </a:extLst>
                </a:gridCol>
                <a:gridCol w="864781">
                  <a:extLst>
                    <a:ext uri="{9D8B030D-6E8A-4147-A177-3AD203B41FA5}">
                      <a16:colId xmlns:a16="http://schemas.microsoft.com/office/drawing/2014/main" val="1400360626"/>
                    </a:ext>
                  </a:extLst>
                </a:gridCol>
                <a:gridCol w="783266">
                  <a:extLst>
                    <a:ext uri="{9D8B030D-6E8A-4147-A177-3AD203B41FA5}">
                      <a16:colId xmlns:a16="http://schemas.microsoft.com/office/drawing/2014/main" val="386493957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572899746"/>
                    </a:ext>
                  </a:extLst>
                </a:gridCol>
              </a:tblGrid>
              <a:tr h="74916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b"/>
                </a:tc>
                <a:tc gridSpan="3"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Home Discharge (%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-Day Readmission (%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dmission Mortality (%) 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endPara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endPara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endPara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0" lang="en-US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dian Readmission LOS (days) [IQR]</a:t>
                      </a:r>
                      <a:endParaRPr lang="en-US" sz="1200" dirty="0"/>
                    </a:p>
                  </a:txBody>
                  <a:tcPr marL="7124" marR="7124" marT="7124" marB="0" anchor="ctr"/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</a:t>
                      </a:r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dmission Cost </a:t>
                      </a:r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$1,000) [IQR]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b"/>
                </a:tc>
                <a:extLst>
                  <a:ext uri="{0D108BD9-81ED-4DB2-BD59-A6C34878D82A}">
                    <a16:rowId xmlns:a16="http://schemas.microsoft.com/office/drawing/2014/main" val="2244890070"/>
                  </a:ext>
                </a:extLst>
              </a:tr>
              <a:tr h="55179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VTE 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19,391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TE 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8,806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VTE 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19,391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TE 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8,806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VTE 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70,829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TE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 2,634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VTE 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70,829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TE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 2,634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VTE 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70,829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TE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 2,634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7784159"/>
                  </a:ext>
                </a:extLst>
              </a:tr>
              <a:tr h="3702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ophage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[3-9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[3-11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6.0-23.1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6.7-22.8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455289377"/>
                  </a:ext>
                </a:extLst>
              </a:tr>
              <a:tr h="3702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lmonar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[2-7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[3-11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5.3-17.0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8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7.6-28.8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extLst>
                  <a:ext uri="{0D108BD9-81ED-4DB2-BD59-A6C34878D82A}">
                    <a16:rowId xmlns:a16="http://schemas.microsoft.com/office/drawing/2014/main" val="1199779019"/>
                  </a:ext>
                </a:extLst>
              </a:tr>
              <a:tr h="3702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tri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[3-9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[3-11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6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6.2-22.6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6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7.4-27.8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extLst>
                  <a:ext uri="{0D108BD9-81ED-4DB2-BD59-A6C34878D82A}">
                    <a16:rowId xmlns:a16="http://schemas.microsoft.com/office/drawing/2014/main" val="2366685166"/>
                  </a:ext>
                </a:extLst>
              </a:tr>
              <a:tr h="3702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creati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[3-8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[3-8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5.8-19.1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6.6-20.7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extLst>
                  <a:ext uri="{0D108BD9-81ED-4DB2-BD59-A6C34878D82A}">
                    <a16:rowId xmlns:a16="http://schemas.microsoft.com/office/drawing/2014/main" val="1356915424"/>
                  </a:ext>
                </a:extLst>
              </a:tr>
              <a:tr h="3702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oni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[3-8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[3-9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5.4-16.7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6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6.2-20.2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extLst>
                  <a:ext uri="{0D108BD9-81ED-4DB2-BD59-A6C34878D82A}">
                    <a16:rowId xmlns:a16="http://schemas.microsoft.com/office/drawing/2014/main" val="116776460"/>
                  </a:ext>
                </a:extLst>
              </a:tr>
              <a:tr h="3702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ta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[3-7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[3-11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5.2-15.9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5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6.1-24.6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extLst>
                  <a:ext uri="{0D108BD9-81ED-4DB2-BD59-A6C34878D82A}">
                    <a16:rowId xmlns:a16="http://schemas.microsoft.com/office/drawing/2014/main" val="1365534316"/>
                  </a:ext>
                </a:extLst>
              </a:tr>
              <a:tr h="3702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obiliary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[3-7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[3-9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5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6.1-19.0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6.8-26.7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/>
                </a:tc>
                <a:extLst>
                  <a:ext uri="{0D108BD9-81ED-4DB2-BD59-A6C34878D82A}">
                    <a16:rowId xmlns:a16="http://schemas.microsoft.com/office/drawing/2014/main" val="1193610939"/>
                  </a:ext>
                </a:extLst>
              </a:tr>
              <a:tr h="3702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Cohor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[3-8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[3-9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4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5.5-17.5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3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6.5-22.1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24" marR="7124" marT="712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3444485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7D3DF426-A324-49E5-A5A0-E0A152F2054A}"/>
              </a:ext>
            </a:extLst>
          </p:cNvPr>
          <p:cNvSpPr txBox="1"/>
          <p:nvPr/>
        </p:nvSpPr>
        <p:spPr>
          <a:xfrm>
            <a:off x="0" y="4630549"/>
            <a:ext cx="115027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bbreviations: LOS, length of stay; IQR, interquartile range;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VT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no venous thromboembolism; VTE, venous thromboembolism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1CAC642-DE54-46FB-99A7-4B3A6762FA36}"/>
              </a:ext>
            </a:extLst>
          </p:cNvPr>
          <p:cNvSpPr txBox="1"/>
          <p:nvPr/>
        </p:nvSpPr>
        <p:spPr>
          <a:xfrm>
            <a:off x="0" y="260304"/>
            <a:ext cx="115027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upplementary Tabl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adjusted post-discharge outcomes stratified by VTE incidence and resection type </a:t>
            </a:r>
          </a:p>
        </p:txBody>
      </p:sp>
    </p:spTree>
    <p:extLst>
      <p:ext uri="{BB962C8B-B14F-4D97-AF65-F5344CB8AC3E}">
        <p14:creationId xmlns:p14="http://schemas.microsoft.com/office/powerpoint/2010/main" val="34195288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95</Words>
  <Application>Microsoft Macintosh PowerPoint</Application>
  <PresentationFormat>Widescreen</PresentationFormat>
  <Paragraphs>20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Chelsea (Medical Student)</dc:creator>
  <cp:lastModifiedBy>Chelsea Pan</cp:lastModifiedBy>
  <cp:revision>6</cp:revision>
  <dcterms:created xsi:type="dcterms:W3CDTF">2022-04-23T20:22:38Z</dcterms:created>
  <dcterms:modified xsi:type="dcterms:W3CDTF">2022-05-26T01:57:12Z</dcterms:modified>
</cp:coreProperties>
</file>